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B7FED2A-C938-4DF3-AC95-E05F6455FCE0}" v="2" dt="2023-04-14T10:58:57.28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9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80" y="12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엄 경현" userId="006d52b91ace3e0e" providerId="LiveId" clId="{3B7FED2A-C938-4DF3-AC95-E05F6455FCE0}"/>
    <pc:docChg chg="custSel addSld delSld modSld modMainMaster">
      <pc:chgData name="엄 경현" userId="006d52b91ace3e0e" providerId="LiveId" clId="{3B7FED2A-C938-4DF3-AC95-E05F6455FCE0}" dt="2023-04-14T10:58:58.763" v="3" actId="47"/>
      <pc:docMkLst>
        <pc:docMk/>
      </pc:docMkLst>
      <pc:sldChg chg="delSp modSp del mod">
        <pc:chgData name="엄 경현" userId="006d52b91ace3e0e" providerId="LiveId" clId="{3B7FED2A-C938-4DF3-AC95-E05F6455FCE0}" dt="2023-04-14T10:58:58.763" v="3" actId="47"/>
        <pc:sldMkLst>
          <pc:docMk/>
          <pc:sldMk cId="3354289845" sldId="274"/>
        </pc:sldMkLst>
        <pc:spChg chg="del mod">
          <ac:chgData name="엄 경현" userId="006d52b91ace3e0e" providerId="LiveId" clId="{3B7FED2A-C938-4DF3-AC95-E05F6455FCE0}" dt="2023-04-14T10:58:56.843" v="1" actId="478"/>
          <ac:spMkLst>
            <pc:docMk/>
            <pc:sldMk cId="3354289845" sldId="274"/>
            <ac:spMk id="4" creationId="{E9368A11-14C6-7A35-A5F8-B6B41112D77D}"/>
          </ac:spMkLst>
        </pc:spChg>
        <pc:graphicFrameChg chg="del mod">
          <ac:chgData name="엄 경현" userId="006d52b91ace3e0e" providerId="LiveId" clId="{3B7FED2A-C938-4DF3-AC95-E05F6455FCE0}" dt="2023-04-14T10:58:56.843" v="1" actId="478"/>
          <ac:graphicFrameMkLst>
            <pc:docMk/>
            <pc:sldMk cId="3354289845" sldId="274"/>
            <ac:graphicFrameMk id="5" creationId="{5F9329DA-9485-A40F-645D-D7D2909ACDA7}"/>
          </ac:graphicFrameMkLst>
        </pc:graphicFrameChg>
      </pc:sldChg>
      <pc:sldChg chg="add">
        <pc:chgData name="엄 경현" userId="006d52b91ace3e0e" providerId="LiveId" clId="{3B7FED2A-C938-4DF3-AC95-E05F6455FCE0}" dt="2023-04-14T10:58:57.267" v="2"/>
        <pc:sldMkLst>
          <pc:docMk/>
          <pc:sldMk cId="2016810074" sldId="275"/>
        </pc:sldMkLst>
      </pc:sldChg>
      <pc:sldMasterChg chg="modSp modSldLayout">
        <pc:chgData name="엄 경현" userId="006d52b91ace3e0e" providerId="LiveId" clId="{3B7FED2A-C938-4DF3-AC95-E05F6455FCE0}" dt="2023-04-14T10:58:35.050" v="0"/>
        <pc:sldMasterMkLst>
          <pc:docMk/>
          <pc:sldMasterMk cId="3509632676" sldId="2147483648"/>
        </pc:sldMasterMkLst>
        <pc:spChg chg="mod">
          <ac:chgData name="엄 경현" userId="006d52b91ace3e0e" providerId="LiveId" clId="{3B7FED2A-C938-4DF3-AC95-E05F6455FCE0}" dt="2023-04-14T10:58:35.050" v="0"/>
          <ac:spMkLst>
            <pc:docMk/>
            <pc:sldMasterMk cId="3509632676" sldId="2147483648"/>
            <ac:spMk id="2" creationId="{B2757B2B-219E-8891-2E6C-8A6D24D024A5}"/>
          </ac:spMkLst>
        </pc:spChg>
        <pc:spChg chg="mod">
          <ac:chgData name="엄 경현" userId="006d52b91ace3e0e" providerId="LiveId" clId="{3B7FED2A-C938-4DF3-AC95-E05F6455FCE0}" dt="2023-04-14T10:58:35.050" v="0"/>
          <ac:spMkLst>
            <pc:docMk/>
            <pc:sldMasterMk cId="3509632676" sldId="2147483648"/>
            <ac:spMk id="3" creationId="{DE97127E-F903-4E11-6D25-D6DBA9D81F49}"/>
          </ac:spMkLst>
        </pc:spChg>
        <pc:spChg chg="mod">
          <ac:chgData name="엄 경현" userId="006d52b91ace3e0e" providerId="LiveId" clId="{3B7FED2A-C938-4DF3-AC95-E05F6455FCE0}" dt="2023-04-14T10:58:35.050" v="0"/>
          <ac:spMkLst>
            <pc:docMk/>
            <pc:sldMasterMk cId="3509632676" sldId="2147483648"/>
            <ac:spMk id="4" creationId="{3AB5DF1A-26A9-3C4B-53EA-8044DC50A553}"/>
          </ac:spMkLst>
        </pc:spChg>
        <pc:spChg chg="mod">
          <ac:chgData name="엄 경현" userId="006d52b91ace3e0e" providerId="LiveId" clId="{3B7FED2A-C938-4DF3-AC95-E05F6455FCE0}" dt="2023-04-14T10:58:35.050" v="0"/>
          <ac:spMkLst>
            <pc:docMk/>
            <pc:sldMasterMk cId="3509632676" sldId="2147483648"/>
            <ac:spMk id="5" creationId="{E4B1ED26-8C88-D02A-7DE4-02BB5A425915}"/>
          </ac:spMkLst>
        </pc:spChg>
        <pc:spChg chg="mod">
          <ac:chgData name="엄 경현" userId="006d52b91ace3e0e" providerId="LiveId" clId="{3B7FED2A-C938-4DF3-AC95-E05F6455FCE0}" dt="2023-04-14T10:58:35.050" v="0"/>
          <ac:spMkLst>
            <pc:docMk/>
            <pc:sldMasterMk cId="3509632676" sldId="2147483648"/>
            <ac:spMk id="6" creationId="{88D97EC5-5780-9E16-C7A6-676CC5E6F87C}"/>
          </ac:spMkLst>
        </pc:spChg>
        <pc:sldLayoutChg chg="modSp">
          <pc:chgData name="엄 경현" userId="006d52b91ace3e0e" providerId="LiveId" clId="{3B7FED2A-C938-4DF3-AC95-E05F6455FCE0}" dt="2023-04-14T10:58:35.050" v="0"/>
          <pc:sldLayoutMkLst>
            <pc:docMk/>
            <pc:sldMasterMk cId="3509632676" sldId="2147483648"/>
            <pc:sldLayoutMk cId="776511143" sldId="2147483649"/>
          </pc:sldLayoutMkLst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776511143" sldId="2147483649"/>
              <ac:spMk id="2" creationId="{1DDF1AB7-47A4-8107-38AE-69505CE4A3D1}"/>
            </ac:spMkLst>
          </pc:spChg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776511143" sldId="2147483649"/>
              <ac:spMk id="3" creationId="{70138077-2E63-B0C1-ED1D-1D79C81216E3}"/>
            </ac:spMkLst>
          </pc:spChg>
        </pc:sldLayoutChg>
        <pc:sldLayoutChg chg="modSp">
          <pc:chgData name="엄 경현" userId="006d52b91ace3e0e" providerId="LiveId" clId="{3B7FED2A-C938-4DF3-AC95-E05F6455FCE0}" dt="2023-04-14T10:58:35.050" v="0"/>
          <pc:sldLayoutMkLst>
            <pc:docMk/>
            <pc:sldMasterMk cId="3509632676" sldId="2147483648"/>
            <pc:sldLayoutMk cId="1475135237" sldId="2147483651"/>
          </pc:sldLayoutMkLst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1475135237" sldId="2147483651"/>
              <ac:spMk id="2" creationId="{5F933602-C4B4-3FDF-A1F6-9860574C616A}"/>
            </ac:spMkLst>
          </pc:spChg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1475135237" sldId="2147483651"/>
              <ac:spMk id="3" creationId="{51D5674E-F2BE-A0B2-63AE-BA1AA5B90A4E}"/>
            </ac:spMkLst>
          </pc:spChg>
        </pc:sldLayoutChg>
        <pc:sldLayoutChg chg="modSp">
          <pc:chgData name="엄 경현" userId="006d52b91ace3e0e" providerId="LiveId" clId="{3B7FED2A-C938-4DF3-AC95-E05F6455FCE0}" dt="2023-04-14T10:58:35.050" v="0"/>
          <pc:sldLayoutMkLst>
            <pc:docMk/>
            <pc:sldMasterMk cId="3509632676" sldId="2147483648"/>
            <pc:sldLayoutMk cId="57912694" sldId="2147483652"/>
          </pc:sldLayoutMkLst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57912694" sldId="2147483652"/>
              <ac:spMk id="3" creationId="{7A8A8F35-678D-387E-3F08-5C1E685BEA1B}"/>
            </ac:spMkLst>
          </pc:spChg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57912694" sldId="2147483652"/>
              <ac:spMk id="4" creationId="{1BA4BD0D-E79D-7800-1425-84486DC5E394}"/>
            </ac:spMkLst>
          </pc:spChg>
        </pc:sldLayoutChg>
        <pc:sldLayoutChg chg="modSp">
          <pc:chgData name="엄 경현" userId="006d52b91ace3e0e" providerId="LiveId" clId="{3B7FED2A-C938-4DF3-AC95-E05F6455FCE0}" dt="2023-04-14T10:58:35.050" v="0"/>
          <pc:sldLayoutMkLst>
            <pc:docMk/>
            <pc:sldMasterMk cId="3509632676" sldId="2147483648"/>
            <pc:sldLayoutMk cId="3781557258" sldId="2147483653"/>
          </pc:sldLayoutMkLst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3781557258" sldId="2147483653"/>
              <ac:spMk id="2" creationId="{E66345A1-BF50-A8F1-E2E0-91CE13CF938D}"/>
            </ac:spMkLst>
          </pc:spChg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3781557258" sldId="2147483653"/>
              <ac:spMk id="3" creationId="{CDF161EA-69D4-72E0-914D-3FFB775E15EB}"/>
            </ac:spMkLst>
          </pc:spChg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3781557258" sldId="2147483653"/>
              <ac:spMk id="4" creationId="{B8392BD1-BDF1-0CC8-E89F-720B352E60A8}"/>
            </ac:spMkLst>
          </pc:spChg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3781557258" sldId="2147483653"/>
              <ac:spMk id="5" creationId="{CBCF0753-4803-F555-6060-B66B857210A2}"/>
            </ac:spMkLst>
          </pc:spChg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3781557258" sldId="2147483653"/>
              <ac:spMk id="6" creationId="{16690A9B-CAFD-9105-EA52-54D22019129A}"/>
            </ac:spMkLst>
          </pc:spChg>
        </pc:sldLayoutChg>
        <pc:sldLayoutChg chg="modSp">
          <pc:chgData name="엄 경현" userId="006d52b91ace3e0e" providerId="LiveId" clId="{3B7FED2A-C938-4DF3-AC95-E05F6455FCE0}" dt="2023-04-14T10:58:35.050" v="0"/>
          <pc:sldLayoutMkLst>
            <pc:docMk/>
            <pc:sldMasterMk cId="3509632676" sldId="2147483648"/>
            <pc:sldLayoutMk cId="2433973534" sldId="2147483656"/>
          </pc:sldLayoutMkLst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2433973534" sldId="2147483656"/>
              <ac:spMk id="2" creationId="{61FBAEED-573B-DC27-9ADB-C3AC3C6CBBD1}"/>
            </ac:spMkLst>
          </pc:spChg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2433973534" sldId="2147483656"/>
              <ac:spMk id="3" creationId="{11B32543-A38D-9560-33F2-E6AC6FF60134}"/>
            </ac:spMkLst>
          </pc:spChg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2433973534" sldId="2147483656"/>
              <ac:spMk id="4" creationId="{157F1AFC-3795-4855-FF4B-D0BB456F8218}"/>
            </ac:spMkLst>
          </pc:spChg>
        </pc:sldLayoutChg>
        <pc:sldLayoutChg chg="modSp">
          <pc:chgData name="엄 경현" userId="006d52b91ace3e0e" providerId="LiveId" clId="{3B7FED2A-C938-4DF3-AC95-E05F6455FCE0}" dt="2023-04-14T10:58:35.050" v="0"/>
          <pc:sldLayoutMkLst>
            <pc:docMk/>
            <pc:sldMasterMk cId="3509632676" sldId="2147483648"/>
            <pc:sldLayoutMk cId="1038086864" sldId="2147483657"/>
          </pc:sldLayoutMkLst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1038086864" sldId="2147483657"/>
              <ac:spMk id="2" creationId="{36B03928-EC9C-5394-A12D-841DF9B61783}"/>
            </ac:spMkLst>
          </pc:spChg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1038086864" sldId="2147483657"/>
              <ac:spMk id="3" creationId="{553DA566-0CCD-A94B-D69D-4D732DC19B1B}"/>
            </ac:spMkLst>
          </pc:spChg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1038086864" sldId="2147483657"/>
              <ac:spMk id="4" creationId="{551581DB-93D8-79FE-7175-8B6507A0363E}"/>
            </ac:spMkLst>
          </pc:spChg>
        </pc:sldLayoutChg>
        <pc:sldLayoutChg chg="modSp">
          <pc:chgData name="엄 경현" userId="006d52b91ace3e0e" providerId="LiveId" clId="{3B7FED2A-C938-4DF3-AC95-E05F6455FCE0}" dt="2023-04-14T10:58:35.050" v="0"/>
          <pc:sldLayoutMkLst>
            <pc:docMk/>
            <pc:sldMasterMk cId="3509632676" sldId="2147483648"/>
            <pc:sldLayoutMk cId="1692638510" sldId="2147483659"/>
          </pc:sldLayoutMkLst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1692638510" sldId="2147483659"/>
              <ac:spMk id="2" creationId="{95115E4F-2C58-F614-A9B5-180BC19F4F5A}"/>
            </ac:spMkLst>
          </pc:spChg>
          <pc:spChg chg="mod">
            <ac:chgData name="엄 경현" userId="006d52b91ace3e0e" providerId="LiveId" clId="{3B7FED2A-C938-4DF3-AC95-E05F6455FCE0}" dt="2023-04-14T10:58:35.050" v="0"/>
            <ac:spMkLst>
              <pc:docMk/>
              <pc:sldMasterMk cId="3509632676" sldId="2147483648"/>
              <pc:sldLayoutMk cId="1692638510" sldId="2147483659"/>
              <ac:spMk id="3" creationId="{FA37A397-DEF2-9A67-7C22-09AFEAA37CDF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82E2E-8063-432C-B825-E446F8F095F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07E28E-ED39-417E-96FE-46389295BE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6589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82E2E-8063-432C-B825-E446F8F095F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07E28E-ED39-417E-96FE-46389295BE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3184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82E2E-8063-432C-B825-E446F8F095F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07E28E-ED39-417E-96FE-46389295BE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7550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82E2E-8063-432C-B825-E446F8F095F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07E28E-ED39-417E-96FE-46389295BE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664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82E2E-8063-432C-B825-E446F8F095F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07E28E-ED39-417E-96FE-46389295BE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9033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82E2E-8063-432C-B825-E446F8F095F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07E28E-ED39-417E-96FE-46389295BE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841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82E2E-8063-432C-B825-E446F8F095F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07E28E-ED39-417E-96FE-46389295BE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3897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82E2E-8063-432C-B825-E446F8F095F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07E28E-ED39-417E-96FE-46389295BE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687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82E2E-8063-432C-B825-E446F8F095F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07E28E-ED39-417E-96FE-46389295BE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0498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82E2E-8063-432C-B825-E446F8F095F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07E28E-ED39-417E-96FE-46389295BE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4511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82E2E-8063-432C-B825-E446F8F095F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07E28E-ED39-417E-96FE-46389295BE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9845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482E2E-8063-432C-B825-E446F8F095FF}" type="datetimeFigureOut">
              <a:rPr lang="ko-KR" altLang="en-US" smtClean="0"/>
              <a:t>2023-04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07E28E-ED39-417E-96FE-46389295BE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463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9368A11-14C6-7A35-A5F8-B6B41112D77D}"/>
              </a:ext>
            </a:extLst>
          </p:cNvPr>
          <p:cNvSpPr txBox="1"/>
          <p:nvPr/>
        </p:nvSpPr>
        <p:spPr>
          <a:xfrm>
            <a:off x="0" y="1766529"/>
            <a:ext cx="7648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Supplementary Table 1. List of guide RNA and detecting PCR primer sequences for each target genes</a:t>
            </a:r>
            <a:endParaRPr lang="ko-KR" altLang="en-US" sz="1400" b="1" dirty="0"/>
          </a:p>
        </p:txBody>
      </p:sp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5F9329DA-9485-A40F-645D-D7D2909ACDA7}"/>
              </a:ext>
            </a:extLst>
          </p:cNvPr>
          <p:cNvGraphicFramePr>
            <a:graphicFrameLocks noGrp="1"/>
          </p:cNvGraphicFramePr>
          <p:nvPr/>
        </p:nvGraphicFramePr>
        <p:xfrm>
          <a:off x="236412" y="2148087"/>
          <a:ext cx="8671175" cy="21717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800910">
                  <a:extLst>
                    <a:ext uri="{9D8B030D-6E8A-4147-A177-3AD203B41FA5}">
                      <a16:colId xmlns:a16="http://schemas.microsoft.com/office/drawing/2014/main" val="3498148225"/>
                    </a:ext>
                  </a:extLst>
                </a:gridCol>
                <a:gridCol w="1061720">
                  <a:extLst>
                    <a:ext uri="{9D8B030D-6E8A-4147-A177-3AD203B41FA5}">
                      <a16:colId xmlns:a16="http://schemas.microsoft.com/office/drawing/2014/main" val="227594635"/>
                    </a:ext>
                  </a:extLst>
                </a:gridCol>
                <a:gridCol w="2053908">
                  <a:extLst>
                    <a:ext uri="{9D8B030D-6E8A-4147-A177-3AD203B41FA5}">
                      <a16:colId xmlns:a16="http://schemas.microsoft.com/office/drawing/2014/main" val="1868590271"/>
                    </a:ext>
                  </a:extLst>
                </a:gridCol>
                <a:gridCol w="1820545">
                  <a:extLst>
                    <a:ext uri="{9D8B030D-6E8A-4147-A177-3AD203B41FA5}">
                      <a16:colId xmlns:a16="http://schemas.microsoft.com/office/drawing/2014/main" val="1255470210"/>
                    </a:ext>
                  </a:extLst>
                </a:gridCol>
                <a:gridCol w="1871345">
                  <a:extLst>
                    <a:ext uri="{9D8B030D-6E8A-4147-A177-3AD203B41FA5}">
                      <a16:colId xmlns:a16="http://schemas.microsoft.com/office/drawing/2014/main" val="2979502794"/>
                    </a:ext>
                  </a:extLst>
                </a:gridCol>
                <a:gridCol w="1062747">
                  <a:extLst>
                    <a:ext uri="{9D8B030D-6E8A-4147-A177-3AD203B41FA5}">
                      <a16:colId xmlns:a16="http://schemas.microsoft.com/office/drawing/2014/main" val="2195726252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Gen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Chromosom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guide RNA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Detecting PCR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>
                          <a:effectLst/>
                        </a:rPr>
                        <a:t>Product size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657675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Forward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Revers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71149256"/>
                  </a:ext>
                </a:extLst>
              </a:tr>
              <a:tr h="4004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</a:rPr>
                        <a:t>MSTN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50" u="none" strike="noStrike">
                          <a:effectLst/>
                        </a:rPr>
                        <a:t>2</a:t>
                      </a:r>
                      <a:endParaRPr lang="en-US" altLang="ko-KR" sz="105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</a:rPr>
                        <a:t>CCCAACTGTGGATATATCTGAGG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</a:rPr>
                        <a:t>GAGGTGTTCGTTCGTTTTTC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</a:rPr>
                        <a:t>CTACCAGTTTCCTGTGCTT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50" u="none" strike="noStrike">
                          <a:effectLst/>
                        </a:rPr>
                        <a:t>538</a:t>
                      </a:r>
                      <a:endParaRPr lang="en-US" altLang="ko-KR" sz="105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84921516"/>
                  </a:ext>
                </a:extLst>
              </a:tr>
              <a:tr h="4004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</a:rPr>
                        <a:t>PRNP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50" u="none" strike="noStrike">
                          <a:effectLst/>
                        </a:rPr>
                        <a:t>13</a:t>
                      </a:r>
                      <a:endParaRPr lang="en-US" altLang="ko-KR" sz="105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</a:rPr>
                        <a:t>AAAACCAACATGAAGCATGTGG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</a:rPr>
                        <a:t>CCTGCGGTGTTCAAGATCGA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</a:rPr>
                        <a:t>ATGTTGACACAGTCATGCA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50" u="none" strike="noStrike">
                          <a:effectLst/>
                        </a:rPr>
                        <a:t>571</a:t>
                      </a:r>
                      <a:endParaRPr lang="en-US" altLang="ko-KR" sz="105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/>
                </a:tc>
                <a:extLst>
                  <a:ext uri="{0D108BD9-81ED-4DB2-BD59-A6C34878D82A}">
                    <a16:rowId xmlns:a16="http://schemas.microsoft.com/office/drawing/2014/main" val="2008413239"/>
                  </a:ext>
                </a:extLst>
              </a:tr>
              <a:tr h="4004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</a:rPr>
                        <a:t>BLG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50" u="none" strike="noStrike" dirty="0">
                          <a:effectLst/>
                        </a:rPr>
                        <a:t>11</a:t>
                      </a:r>
                      <a:endParaRPr lang="en-US" altLang="ko-KR" sz="105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</a:rPr>
                        <a:t>CCTGCGGTGTTCAAGATCGATGG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</a:rPr>
                        <a:t>CTCTCCCCAACCTTTTCTC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</a:rPr>
                        <a:t>AGCAAAGAGAGCTCGGGTGT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50" u="none" strike="noStrike" dirty="0">
                          <a:effectLst/>
                        </a:rPr>
                        <a:t>541</a:t>
                      </a:r>
                      <a:endParaRPr lang="en-US" altLang="ko-KR" sz="105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137160" marR="137160" marT="137160" marB="137160" anchor="ctr"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50269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16810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</TotalTime>
  <Words>45</Words>
  <Application>Microsoft Office PowerPoint</Application>
  <PresentationFormat>화면 슬라이드 쇼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엄 경현</dc:creator>
  <cp:lastModifiedBy>엄 경현</cp:lastModifiedBy>
  <cp:revision>1</cp:revision>
  <dcterms:created xsi:type="dcterms:W3CDTF">2023-04-14T10:54:50Z</dcterms:created>
  <dcterms:modified xsi:type="dcterms:W3CDTF">2023-04-14T10:59:00Z</dcterms:modified>
</cp:coreProperties>
</file>